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70" r:id="rId9"/>
    <p:sldId id="271" r:id="rId10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CFE9A189-54E6-4FA9-9CB3-462FE4DE5C15}">
  <a:tblStyle styleId="{CFE9A189-54E6-4FA9-9CB3-462FE4DE5C15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05"/>
  </p:normalViewPr>
  <p:slideViewPr>
    <p:cSldViewPr snapToGrid="0">
      <p:cViewPr varScale="1">
        <p:scale>
          <a:sx n="144" d="100"/>
          <a:sy n="144" d="100"/>
        </p:scale>
        <p:origin x="720" y="19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cea81064e4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cea81064e4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Google Shape;64;gcea81064e4_0_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5" name="Google Shape;65;gcea81064e4_0_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gcea81064e4_0_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2" name="Google Shape;72;gcea81064e4_0_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gcea81064e4_0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9" name="Google Shape;79;gcea81064e4_0_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gcea81064e4_0_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6" name="Google Shape;86;gcea81064e4_0_2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 JHS. Chest Radiograph (pediatric): Radiology reference article. Radiopaedia Blog RSS. https://radiopaedia.org/articles/chest-radiograph-paediatric?lang=us. Published September 19, 2021. Accessed February 4, 2022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cea81064e4_0_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3" name="Google Shape;93;gcea81064e4_0_3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Author’s own imag</a:t>
            </a: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-298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ick Y. Normal brain CT - 2-month-old: Radiology case. Radiopaedia Blog RSS. https://radiopaedia.org/cases/normal-brain-ct-2-month-old-1?lang=us. Published August 2, 2021. Accessed February 6, 2022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06548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Pedi Simulation</a:t>
            </a:r>
            <a:endParaRPr/>
          </a:p>
        </p:txBody>
      </p:sp>
      <p:sp>
        <p:nvSpPr>
          <p:cNvPr id="55" name="Google Shape;55;p13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/>
          </a:p>
        </p:txBody>
      </p:sp>
      <p:graphicFrame>
        <p:nvGraphicFramePr>
          <p:cNvPr id="62" name="Google Shape;62;p14"/>
          <p:cNvGraphicFramePr/>
          <p:nvPr>
            <p:extLst>
              <p:ext uri="{D42A27DB-BD31-4B8C-83A1-F6EECF244321}">
                <p14:modId xmlns:p14="http://schemas.microsoft.com/office/powerpoint/2010/main" val="3402657156"/>
              </p:ext>
            </p:extLst>
          </p:nvPr>
        </p:nvGraphicFramePr>
        <p:xfrm>
          <a:off x="2782850" y="834024"/>
          <a:ext cx="3233025" cy="3274839"/>
        </p:xfrm>
        <a:graphic>
          <a:graphicData uri="http://schemas.openxmlformats.org/drawingml/2006/table">
            <a:tbl>
              <a:tblPr>
                <a:noFill/>
                <a:tableStyleId>{CFE9A189-54E6-4FA9-9CB3-462FE4DE5C15}</a:tableStyleId>
              </a:tblPr>
              <a:tblGrid>
                <a:gridCol w="23847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8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85263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 dirty="0"/>
                        <a:t>ELECTROLYTES</a:t>
                      </a:r>
                      <a:endParaRPr sz="12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6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Sodium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138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Potassium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3.5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hloride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106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O2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>
                          <a:solidFill>
                            <a:srgbClr val="FF0000"/>
                          </a:solidFill>
                        </a:rPr>
                        <a:t>18</a:t>
                      </a:r>
                      <a:endParaRPr sz="1200" b="1">
                        <a:solidFill>
                          <a:srgbClr val="FF0000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Anion gap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11.5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reatinine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0.2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BUN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4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Glucose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>
                          <a:solidFill>
                            <a:srgbClr val="FF0000"/>
                          </a:solidFill>
                        </a:rPr>
                        <a:t>55</a:t>
                      </a:r>
                      <a:endParaRPr sz="1200" b="1">
                        <a:solidFill>
                          <a:srgbClr val="FF0000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1064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alcium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 dirty="0"/>
                        <a:t>9.2</a:t>
                      </a:r>
                      <a:endParaRPr sz="12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8" name="Google Shape;68;p1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/>
          </a:p>
        </p:txBody>
      </p:sp>
      <p:graphicFrame>
        <p:nvGraphicFramePr>
          <p:cNvPr id="69" name="Google Shape;69;p15"/>
          <p:cNvGraphicFramePr/>
          <p:nvPr/>
        </p:nvGraphicFramePr>
        <p:xfrm>
          <a:off x="3137100" y="893085"/>
          <a:ext cx="3001300" cy="3539100"/>
        </p:xfrm>
        <a:graphic>
          <a:graphicData uri="http://schemas.openxmlformats.org/drawingml/2006/table">
            <a:tbl>
              <a:tblPr>
                <a:noFill/>
                <a:tableStyleId>{CFE9A189-54E6-4FA9-9CB3-462FE4DE5C15}</a:tableStyleId>
              </a:tblPr>
              <a:tblGrid>
                <a:gridCol w="2213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74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5340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BC c DIFF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6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WBC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8.2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Hemoglobin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.2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Hematocrit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0.5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MCV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0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Platelet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5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354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Segmented Neutrophils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0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Lymphocytes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Monocytes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Eosinophils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44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Basophils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5" name="Google Shape;75;p16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/>
          </a:p>
        </p:txBody>
      </p:sp>
      <p:graphicFrame>
        <p:nvGraphicFramePr>
          <p:cNvPr id="76" name="Google Shape;76;p16"/>
          <p:cNvGraphicFramePr/>
          <p:nvPr>
            <p:extLst>
              <p:ext uri="{D42A27DB-BD31-4B8C-83A1-F6EECF244321}">
                <p14:modId xmlns:p14="http://schemas.microsoft.com/office/powerpoint/2010/main" val="2310097023"/>
              </p:ext>
            </p:extLst>
          </p:nvPr>
        </p:nvGraphicFramePr>
        <p:xfrm>
          <a:off x="2776600" y="1418515"/>
          <a:ext cx="3408400" cy="3234775"/>
        </p:xfrm>
        <a:graphic>
          <a:graphicData uri="http://schemas.openxmlformats.org/drawingml/2006/table">
            <a:tbl>
              <a:tblPr>
                <a:noFill/>
                <a:tableStyleId>{CFE9A189-54E6-4FA9-9CB3-462FE4DE5C15}</a:tableStyleId>
              </a:tblPr>
              <a:tblGrid>
                <a:gridCol w="25141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4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129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VBG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6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pH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.25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CO2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5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HCO3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9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/>
                        <a:t>BE</a:t>
                      </a:r>
                      <a:endParaRPr sz="12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-1</a:t>
                      </a:r>
                      <a:endParaRPr sz="12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129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6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60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 dirty="0"/>
                        <a:t>Lactic WB</a:t>
                      </a: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dirty="0"/>
                        <a:t>1</a:t>
                      </a:r>
                      <a:endParaRPr sz="1200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 dirty="0"/>
                        <a:t>Magnesium</a:t>
                      </a: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/>
                        <a:t>2</a:t>
                      </a:r>
                      <a:endParaRPr sz="1200" dirty="0"/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299745"/>
                  </a:ext>
                </a:extLst>
              </a:tr>
              <a:tr h="34412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 b="1" dirty="0"/>
                        <a:t>Phosphorous</a:t>
                      </a: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/>
                        <a:t>5</a:t>
                      </a:r>
                      <a:endParaRPr sz="1200" dirty="0"/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43941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7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7"/>
          <p:cNvSpPr txBox="1">
            <a:spLocks noGrp="1"/>
          </p:cNvSpPr>
          <p:nvPr>
            <p:ph type="body" idx="1"/>
          </p:nvPr>
        </p:nvSpPr>
        <p:spPr>
          <a:xfrm>
            <a:off x="311700" y="4019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 dirty="0"/>
          </a:p>
        </p:txBody>
      </p:sp>
      <p:graphicFrame>
        <p:nvGraphicFramePr>
          <p:cNvPr id="83" name="Google Shape;83;p17"/>
          <p:cNvGraphicFramePr/>
          <p:nvPr/>
        </p:nvGraphicFramePr>
        <p:xfrm>
          <a:off x="3685125" y="401975"/>
          <a:ext cx="1924050" cy="4306700"/>
        </p:xfrm>
        <a:graphic>
          <a:graphicData uri="http://schemas.openxmlformats.org/drawingml/2006/table">
            <a:tbl>
              <a:tblPr>
                <a:noFill/>
                <a:tableStyleId>{CFE9A189-54E6-4FA9-9CB3-462FE4DE5C15}</a:tableStyleId>
              </a:tblPr>
              <a:tblGrid>
                <a:gridCol w="12438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0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17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rinalysis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Turbidity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on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Color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yellow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A pH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6.5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Spec Gravity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1.2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glucos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blood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ketones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trac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protein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 dirty="0"/>
                        <a:t>U urobilinogen</a:t>
                      </a:r>
                      <a:endParaRPr sz="10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0.4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bilirubin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leukocyte ester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nitrit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egativ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WBC/HPF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0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RBC/HPF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0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bacteria/HPF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on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117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Squamous epith/LPF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none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645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/>
                        <a:t>U Mucus/LPF</a:t>
                      </a:r>
                      <a:endParaRPr sz="1000" b="1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 b="1" dirty="0"/>
                        <a:t>none</a:t>
                      </a:r>
                      <a:endParaRPr sz="10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9" name="Google Shape;89;p18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/>
          </a:p>
        </p:txBody>
      </p:sp>
      <p:pic>
        <p:nvPicPr>
          <p:cNvPr id="5" name="Picture 4" descr="Chest radiograph (pediatric) | Radiology Reference Article | Radiopaedia.org">
            <a:extLst>
              <a:ext uri="{FF2B5EF4-FFF2-40B4-BE49-F238E27FC236}">
                <a16:creationId xmlns:a16="http://schemas.microsoft.com/office/drawing/2014/main" id="{832FB140-8F2E-459F-9B3A-A698A97D80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4127" y="466725"/>
            <a:ext cx="4055745" cy="42100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1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6" name="Google Shape;96;p19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endParaRPr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C4C639B-1A27-4CA4-9496-A39424FE50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5300" y="191452"/>
            <a:ext cx="5613400" cy="476059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6498B-455C-4C76-BA01-8462C2C88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A45F5C-38F4-4201-BD0E-99B9C59641E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A close up of the moon&#10;&#10;Description automatically generated with medium confidence">
            <a:extLst>
              <a:ext uri="{FF2B5EF4-FFF2-40B4-BE49-F238E27FC236}">
                <a16:creationId xmlns:a16="http://schemas.microsoft.com/office/drawing/2014/main" id="{A7D631A2-AC58-449B-91B1-5B1D9AE5EC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3813" y="359501"/>
            <a:ext cx="3950360" cy="442449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9033272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F6958-CF8E-4791-BCED-4E14A5F85C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F502D8-9460-48A3-A24E-3620B47B7C1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92D238F-2B98-4F07-AD64-25B5DA430E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8330109"/>
              </p:ext>
            </p:extLst>
          </p:nvPr>
        </p:nvGraphicFramePr>
        <p:xfrm>
          <a:off x="1524000" y="1798534"/>
          <a:ext cx="4127818" cy="1968649"/>
        </p:xfrm>
        <a:graphic>
          <a:graphicData uri="http://schemas.openxmlformats.org/drawingml/2006/table">
            <a:tbl>
              <a:tblPr firstRow="1" bandRow="1">
                <a:tableStyleId>{CFE9A189-54E6-4FA9-9CB3-462FE4DE5C15}</a:tableStyleId>
              </a:tblPr>
              <a:tblGrid>
                <a:gridCol w="2038597">
                  <a:extLst>
                    <a:ext uri="{9D8B030D-6E8A-4147-A177-3AD203B41FA5}">
                      <a16:colId xmlns:a16="http://schemas.microsoft.com/office/drawing/2014/main" val="3795366073"/>
                    </a:ext>
                  </a:extLst>
                </a:gridCol>
                <a:gridCol w="2089221">
                  <a:extLst>
                    <a:ext uri="{9D8B030D-6E8A-4147-A177-3AD203B41FA5}">
                      <a16:colId xmlns:a16="http://schemas.microsoft.com/office/drawing/2014/main" val="199746651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b="1" dirty="0"/>
                        <a:t>CSF Stu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 b="1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82151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b="1" dirty="0"/>
                        <a:t>WB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98999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b="1" dirty="0"/>
                        <a:t>RB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634637"/>
                  </a:ext>
                </a:extLst>
              </a:tr>
              <a:tr h="485289">
                <a:tc>
                  <a:txBody>
                    <a:bodyPr/>
                    <a:lstStyle/>
                    <a:p>
                      <a:r>
                        <a:rPr lang="en-US" sz="1200" b="1" dirty="0"/>
                        <a:t>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99064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b="1" dirty="0"/>
                        <a:t>Gluco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5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73434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24277071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25</Words>
  <Application>Microsoft Macintosh PowerPoint</Application>
  <PresentationFormat>On-screen Show (16:9)</PresentationFormat>
  <Paragraphs>103</Paragraphs>
  <Slides>9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Simple Light</vt:lpstr>
      <vt:lpstr>Pedi Simul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di Simulation</dc:title>
  <cp:lastModifiedBy>Patricia Hartz</cp:lastModifiedBy>
  <cp:revision>10</cp:revision>
  <dcterms:modified xsi:type="dcterms:W3CDTF">2022-03-26T15:44:27Z</dcterms:modified>
</cp:coreProperties>
</file>